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63" r:id="rId3"/>
    <p:sldId id="270" r:id="rId4"/>
    <p:sldId id="269" r:id="rId5"/>
    <p:sldId id="271" r:id="rId6"/>
    <p:sldId id="265" r:id="rId7"/>
    <p:sldId id="256" r:id="rId8"/>
    <p:sldId id="268" r:id="rId9"/>
    <p:sldId id="258" r:id="rId10"/>
    <p:sldId id="272" r:id="rId11"/>
    <p:sldId id="261" r:id="rId12"/>
    <p:sldId id="273" r:id="rId13"/>
    <p:sldId id="274" r:id="rId14"/>
    <p:sldId id="267" r:id="rId1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608" y="-4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5838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84930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70381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3910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49303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49170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76871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03855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33458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11350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27666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31667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4351A5-AB69-4A29-8189-14EE0C98945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E741B4-E286-487E-891F-86F88B7DBC0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523124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ctrTitle"/>
          </p:nvPr>
        </p:nvSpPr>
        <p:spPr>
          <a:xfrm>
            <a:off x="304800" y="2133600"/>
            <a:ext cx="8458200" cy="1470025"/>
          </a:xfrm>
        </p:spPr>
        <p:txBody>
          <a:bodyPr>
            <a:normAutofit/>
          </a:bodyPr>
          <a:lstStyle/>
          <a:p>
            <a:pPr algn="l"/>
            <a:r>
              <a:rPr lang="en-US" sz="2000" dirty="0" err="1" smtClean="0"/>
              <a:t>Electropherograms</a:t>
            </a:r>
            <a:r>
              <a:rPr lang="en-US" sz="2000" dirty="0" smtClean="0"/>
              <a:t> of the 13 </a:t>
            </a:r>
            <a:r>
              <a:rPr lang="en-US" sz="2000" dirty="0" err="1" smtClean="0"/>
              <a:t>missense</a:t>
            </a:r>
            <a:r>
              <a:rPr lang="en-US" sz="2000" dirty="0" smtClean="0"/>
              <a:t> mutations in </a:t>
            </a:r>
            <a:r>
              <a:rPr lang="en-US" sz="2000" dirty="0" smtClean="0"/>
              <a:t>EGFR </a:t>
            </a:r>
            <a:r>
              <a:rPr lang="en-US" sz="2000" dirty="0" err="1" smtClean="0"/>
              <a:t>exons</a:t>
            </a:r>
            <a:r>
              <a:rPr lang="en-US" sz="2000" dirty="0" smtClean="0"/>
              <a:t> 19–23 detected in </a:t>
            </a:r>
            <a:r>
              <a:rPr lang="en-US" sz="2000" dirty="0" err="1" smtClean="0"/>
              <a:t>hepatocellular</a:t>
            </a:r>
            <a:r>
              <a:rPr lang="en-US" sz="2000" dirty="0" smtClean="0"/>
              <a:t> carcinoma tissues. (linked to Table3 in the main text)</a:t>
            </a:r>
            <a:endParaRPr lang="en-US" sz="2000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990600" y="4800600"/>
            <a:ext cx="457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</a:t>
            </a:r>
            <a:r>
              <a:rPr lang="en-US" dirty="0"/>
              <a:t>45T </a:t>
            </a:r>
            <a:r>
              <a:rPr lang="en-US" dirty="0" smtClean="0"/>
              <a:t>p.S912P (c.2734T&gt;C, TCC&gt;CCC)</a:t>
            </a:r>
            <a:endParaRPr lang="en-US" dirty="0"/>
          </a:p>
        </p:txBody>
      </p:sp>
      <p:grpSp>
        <p:nvGrpSpPr>
          <p:cNvPr id="8" name="Group 7"/>
          <p:cNvGrpSpPr/>
          <p:nvPr/>
        </p:nvGrpSpPr>
        <p:grpSpPr>
          <a:xfrm>
            <a:off x="1534001" y="533400"/>
            <a:ext cx="5397131" cy="3481349"/>
            <a:chOff x="1534001" y="533400"/>
            <a:chExt cx="5397131" cy="3481349"/>
          </a:xfrm>
        </p:grpSpPr>
        <p:grpSp>
          <p:nvGrpSpPr>
            <p:cNvPr id="7" name="Group 6"/>
            <p:cNvGrpSpPr/>
            <p:nvPr/>
          </p:nvGrpSpPr>
          <p:grpSpPr>
            <a:xfrm>
              <a:off x="1667959" y="2538374"/>
              <a:ext cx="5129213" cy="1476375"/>
              <a:chOff x="2257425" y="2590800"/>
              <a:chExt cx="5129213" cy="1476375"/>
            </a:xfrm>
          </p:grpSpPr>
          <p:pic>
            <p:nvPicPr>
              <p:cNvPr id="4098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1963"/>
              <a:stretch/>
            </p:blipFill>
            <p:spPr bwMode="auto">
              <a:xfrm>
                <a:off x="2430758" y="2790825"/>
                <a:ext cx="4955880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2257425" y="2590800"/>
                <a:ext cx="7572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1534001" y="533400"/>
              <a:ext cx="5397131" cy="1812863"/>
              <a:chOff x="1685482" y="762000"/>
              <a:chExt cx="5339604" cy="1651443"/>
            </a:xfrm>
          </p:grpSpPr>
          <p:pic>
            <p:nvPicPr>
              <p:cNvPr id="4099" name="Picture 3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r="2086"/>
              <a:stretch/>
            </p:blipFill>
            <p:spPr bwMode="auto">
              <a:xfrm>
                <a:off x="1685482" y="1137093"/>
                <a:ext cx="5339604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1757363" y="762000"/>
                <a:ext cx="681037" cy="381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</p:grpSp>
      <p:sp>
        <p:nvSpPr>
          <p:cNvPr id="2" name="Rectangle 1"/>
          <p:cNvSpPr/>
          <p:nvPr/>
        </p:nvSpPr>
        <p:spPr>
          <a:xfrm>
            <a:off x="4495800" y="951641"/>
            <a:ext cx="381000" cy="324895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2680673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85800" y="4844534"/>
            <a:ext cx="5867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ase </a:t>
            </a:r>
            <a:r>
              <a:rPr lang="en-US" dirty="0" smtClean="0"/>
              <a:t>56T p.P937L(c.2810C&gt;T ,CCC&gt;CTC)</a:t>
            </a:r>
            <a:endParaRPr lang="en-US" dirty="0"/>
          </a:p>
        </p:txBody>
      </p:sp>
      <p:grpSp>
        <p:nvGrpSpPr>
          <p:cNvPr id="7" name="Group 6"/>
          <p:cNvGrpSpPr/>
          <p:nvPr/>
        </p:nvGrpSpPr>
        <p:grpSpPr>
          <a:xfrm>
            <a:off x="2698898" y="1272363"/>
            <a:ext cx="5131981" cy="2939693"/>
            <a:chOff x="2698898" y="1308457"/>
            <a:chExt cx="5131981" cy="2939693"/>
          </a:xfrm>
        </p:grpSpPr>
        <p:pic>
          <p:nvPicPr>
            <p:cNvPr id="614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8141"/>
            <a:stretch/>
          </p:blipFill>
          <p:spPr bwMode="auto">
            <a:xfrm>
              <a:off x="2698898" y="2859579"/>
              <a:ext cx="5131981" cy="13885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4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9069" r="6744"/>
            <a:stretch/>
          </p:blipFill>
          <p:spPr bwMode="auto">
            <a:xfrm>
              <a:off x="2756449" y="1308457"/>
              <a:ext cx="4926501" cy="13394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6" name="Rectangle 5"/>
          <p:cNvSpPr/>
          <p:nvPr/>
        </p:nvSpPr>
        <p:spPr>
          <a:xfrm>
            <a:off x="5029200" y="1219200"/>
            <a:ext cx="381000" cy="32004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2375449" y="963282"/>
            <a:ext cx="76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392325" y="2638819"/>
            <a:ext cx="5493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8880390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4586"/>
          <a:stretch/>
        </p:blipFill>
        <p:spPr bwMode="auto">
          <a:xfrm>
            <a:off x="2727250" y="2590800"/>
            <a:ext cx="4851991" cy="14009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057400" y="2590800"/>
            <a:ext cx="762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T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066800" y="4572000"/>
            <a:ext cx="5257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36T p.T940A (c.2818A&gt;G, ACC&gt;GCC</a:t>
            </a:r>
            <a:r>
              <a:rPr lang="en-US" dirty="0"/>
              <a:t>)</a:t>
            </a:r>
          </a:p>
          <a:p>
            <a:endParaRPr lang="en-US" dirty="0"/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795" r="3785"/>
          <a:stretch/>
        </p:blipFill>
        <p:spPr bwMode="auto">
          <a:xfrm>
            <a:off x="2704213" y="969335"/>
            <a:ext cx="4857304" cy="12814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 flipH="1">
            <a:off x="2057400" y="784669"/>
            <a:ext cx="609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5153245" y="784669"/>
            <a:ext cx="409355" cy="33301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099498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127051" y="2674398"/>
            <a:ext cx="5899299" cy="1600876"/>
            <a:chOff x="1657678" y="2677399"/>
            <a:chExt cx="5788918" cy="1570751"/>
          </a:xfrm>
        </p:grpSpPr>
        <p:pic>
          <p:nvPicPr>
            <p:cNvPr id="614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7380"/>
            <a:stretch/>
          </p:blipFill>
          <p:spPr bwMode="auto">
            <a:xfrm>
              <a:off x="1969621" y="2936863"/>
              <a:ext cx="5476975" cy="13112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1657678" y="2677399"/>
              <a:ext cx="6238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MT</a:t>
              </a:r>
              <a:endParaRPr lang="en-US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1127051" y="762001"/>
            <a:ext cx="5867400" cy="1684094"/>
            <a:chOff x="1458433" y="980808"/>
            <a:chExt cx="5567917" cy="1480629"/>
          </a:xfrm>
        </p:grpSpPr>
        <p:pic>
          <p:nvPicPr>
            <p:cNvPr id="614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r="10481"/>
            <a:stretch/>
          </p:blipFill>
          <p:spPr bwMode="auto">
            <a:xfrm>
              <a:off x="1579106" y="1194798"/>
              <a:ext cx="5447244" cy="12666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>
              <a:off x="1458433" y="980808"/>
              <a:ext cx="5334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WT</a:t>
              </a:r>
              <a:endParaRPr lang="en-US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371599" y="4800600"/>
            <a:ext cx="52578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5T p.M947V (c.2839A&gt;G, ATG&gt;GTG)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4724400" y="1005397"/>
            <a:ext cx="457200" cy="33380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7776323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257" r="1668"/>
          <a:stretch/>
        </p:blipFill>
        <p:spPr bwMode="auto">
          <a:xfrm>
            <a:off x="2009552" y="2590800"/>
            <a:ext cx="5381847" cy="1276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295400" y="4648200"/>
            <a:ext cx="4343400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 smtClean="0"/>
              <a:t>Case 41T p.M947T(c.2840T&gt;C, ATG&gt;ACG)</a:t>
            </a:r>
            <a:endParaRPr lang="en-US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7987" r="1873"/>
          <a:stretch/>
        </p:blipFill>
        <p:spPr bwMode="auto">
          <a:xfrm>
            <a:off x="2009552" y="883406"/>
            <a:ext cx="5381848" cy="13073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4876800" y="876300"/>
            <a:ext cx="304800" cy="3429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1600200" y="883406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600200" y="2362200"/>
            <a:ext cx="76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28422921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38200" y="5029200"/>
            <a:ext cx="403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6T, p.L730P(c.2189T&gt;C, CTC&gt;CCC)</a:t>
            </a:r>
            <a:endParaRPr 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332" t="1426" r="2242" b="-1426"/>
          <a:stretch/>
        </p:blipFill>
        <p:spPr bwMode="auto">
          <a:xfrm>
            <a:off x="1873825" y="3344378"/>
            <a:ext cx="4807528" cy="145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7378"/>
          <a:stretch/>
        </p:blipFill>
        <p:spPr bwMode="auto">
          <a:xfrm>
            <a:off x="1828800" y="1650395"/>
            <a:ext cx="4887109" cy="12974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4876800" y="1600200"/>
            <a:ext cx="381000" cy="316706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1371600" y="13716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371600" y="3276599"/>
            <a:ext cx="502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7024091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50334" y="5334000"/>
            <a:ext cx="42884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2T, p.V742I(</a:t>
            </a:r>
            <a:r>
              <a:rPr lang="en-US" dirty="0"/>
              <a:t>c.2224G&gt;A</a:t>
            </a:r>
            <a:r>
              <a:rPr lang="en-US" dirty="0" smtClean="0"/>
              <a:t>, GTC&gt;ATC)</a:t>
            </a:r>
            <a:endParaRPr lang="en-US" dirty="0"/>
          </a:p>
          <a:p>
            <a:endParaRPr lang="en-US" dirty="0"/>
          </a:p>
        </p:txBody>
      </p:sp>
      <p:grpSp>
        <p:nvGrpSpPr>
          <p:cNvPr id="3" name="Group 2"/>
          <p:cNvGrpSpPr/>
          <p:nvPr/>
        </p:nvGrpSpPr>
        <p:grpSpPr>
          <a:xfrm>
            <a:off x="1998921" y="1554718"/>
            <a:ext cx="4763386" cy="2922032"/>
            <a:chOff x="1998921" y="1554718"/>
            <a:chExt cx="4763386" cy="2922032"/>
          </a:xfrm>
        </p:grpSpPr>
        <p:grpSp>
          <p:nvGrpSpPr>
            <p:cNvPr id="8" name="Group 7"/>
            <p:cNvGrpSpPr/>
            <p:nvPr/>
          </p:nvGrpSpPr>
          <p:grpSpPr>
            <a:xfrm>
              <a:off x="1998921" y="3015734"/>
              <a:ext cx="4763386" cy="1461016"/>
              <a:chOff x="1998921" y="3015734"/>
              <a:chExt cx="4763386" cy="1461016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9804" r="3809"/>
              <a:stretch/>
            </p:blipFill>
            <p:spPr bwMode="auto">
              <a:xfrm>
                <a:off x="2360428" y="3200400"/>
                <a:ext cx="4401879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998921" y="3015734"/>
                <a:ext cx="6096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1998921" y="1554718"/>
              <a:ext cx="4736805" cy="1461016"/>
              <a:chOff x="1251097" y="1600200"/>
              <a:chExt cx="4736805" cy="1461016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r="7613"/>
              <a:stretch/>
            </p:blipFill>
            <p:spPr bwMode="auto">
              <a:xfrm>
                <a:off x="1359195" y="1784866"/>
                <a:ext cx="4628707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1251097" y="1600200"/>
                <a:ext cx="65390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</p:grpSp>
      <p:sp>
        <p:nvSpPr>
          <p:cNvPr id="2" name="Rectangle 1"/>
          <p:cNvSpPr/>
          <p:nvPr/>
        </p:nvSpPr>
        <p:spPr>
          <a:xfrm>
            <a:off x="4800600" y="1828800"/>
            <a:ext cx="381000" cy="264795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03528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914399" y="1304697"/>
            <a:ext cx="5823621" cy="2847975"/>
            <a:chOff x="1124864" y="1239982"/>
            <a:chExt cx="5823621" cy="284797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00160" y="2811607"/>
              <a:ext cx="5648325" cy="1276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6" name="Group 5"/>
            <p:cNvGrpSpPr/>
            <p:nvPr/>
          </p:nvGrpSpPr>
          <p:grpSpPr>
            <a:xfrm>
              <a:off x="1124864" y="1239982"/>
              <a:ext cx="5720315" cy="1756291"/>
              <a:chOff x="1196302" y="1219200"/>
              <a:chExt cx="5720315" cy="1756291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r="6346"/>
              <a:stretch/>
            </p:blipFill>
            <p:spPr bwMode="auto">
              <a:xfrm>
                <a:off x="1371598" y="1219200"/>
                <a:ext cx="5545019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1196302" y="2606159"/>
                <a:ext cx="58395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</p:grpSp>
      <p:sp>
        <p:nvSpPr>
          <p:cNvPr id="8" name="TextBox 7"/>
          <p:cNvSpPr txBox="1"/>
          <p:nvPr/>
        </p:nvSpPr>
        <p:spPr>
          <a:xfrm>
            <a:off x="1498358" y="5206408"/>
            <a:ext cx="4902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17, p.K757E(c.2269A&gt;G, AAG&gt;GAG)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4648200" y="1304697"/>
            <a:ext cx="381000" cy="30387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838200" y="1143000"/>
            <a:ext cx="762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W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5559944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8605" r="1807"/>
          <a:stretch/>
        </p:blipFill>
        <p:spPr bwMode="auto">
          <a:xfrm>
            <a:off x="1688861" y="3200400"/>
            <a:ext cx="4940539" cy="14653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637470" y="2934936"/>
            <a:ext cx="838411" cy="4240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T</a:t>
            </a:r>
            <a:endParaRPr lang="en-US" dirty="0"/>
          </a:p>
        </p:txBody>
      </p:sp>
      <p:grpSp>
        <p:nvGrpSpPr>
          <p:cNvPr id="6" name="Group 5"/>
          <p:cNvGrpSpPr/>
          <p:nvPr/>
        </p:nvGrpSpPr>
        <p:grpSpPr>
          <a:xfrm>
            <a:off x="1566530" y="1400898"/>
            <a:ext cx="4961804" cy="1538986"/>
            <a:chOff x="2133600" y="990600"/>
            <a:chExt cx="4278003" cy="1332015"/>
          </a:xfrm>
        </p:grpSpPr>
        <p:pic>
          <p:nvPicPr>
            <p:cNvPr id="3075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r="4646"/>
            <a:stretch/>
          </p:blipFill>
          <p:spPr bwMode="auto">
            <a:xfrm>
              <a:off x="2151934" y="1046265"/>
              <a:ext cx="4259669" cy="1276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>
              <a:off x="2133600" y="990600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WT</a:t>
              </a:r>
              <a:endParaRPr lang="en-US" dirty="0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1029586" y="4820093"/>
            <a:ext cx="44213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3T, p.I780T ( </a:t>
            </a:r>
            <a:r>
              <a:rPr lang="en-US" dirty="0"/>
              <a:t>c.2339T&gt;C</a:t>
            </a:r>
            <a:r>
              <a:rPr lang="en-US" dirty="0" smtClean="0"/>
              <a:t>, ATC&gt;ACC)</a:t>
            </a:r>
            <a:endParaRPr lang="en-US" dirty="0"/>
          </a:p>
          <a:p>
            <a:endParaRPr lang="en-US" dirty="0" smtClean="0"/>
          </a:p>
        </p:txBody>
      </p:sp>
      <p:sp>
        <p:nvSpPr>
          <p:cNvPr id="2" name="Rectangle 1"/>
          <p:cNvSpPr/>
          <p:nvPr/>
        </p:nvSpPr>
        <p:spPr>
          <a:xfrm>
            <a:off x="4419600" y="1460170"/>
            <a:ext cx="381000" cy="335992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79787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33945" y="5020086"/>
            <a:ext cx="3995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ase 30T,p.N808S(c.2423A&gt;G, AAT&gt;AGT)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1447801" y="1660814"/>
            <a:ext cx="5715000" cy="2663536"/>
            <a:chOff x="1447801" y="1660814"/>
            <a:chExt cx="5715000" cy="2663536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082" r="5730"/>
            <a:stretch/>
          </p:blipFill>
          <p:spPr bwMode="auto">
            <a:xfrm>
              <a:off x="1447801" y="3048000"/>
              <a:ext cx="5714999" cy="1276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0" name="Picture 4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7412" r="5368"/>
            <a:stretch/>
          </p:blipFill>
          <p:spPr bwMode="auto">
            <a:xfrm>
              <a:off x="1447801" y="1660814"/>
              <a:ext cx="5715000" cy="1276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" name="Rectangle 6"/>
          <p:cNvSpPr/>
          <p:nvPr/>
        </p:nvSpPr>
        <p:spPr>
          <a:xfrm>
            <a:off x="5029200" y="1440008"/>
            <a:ext cx="381000" cy="304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838200" y="12954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838200" y="32766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21671141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95400" y="5047795"/>
            <a:ext cx="3966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ase 30T p.R831C(c.2491C&gt;T,  CGT&gt;TGT)</a:t>
            </a:r>
            <a:endParaRPr 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592" r="2367"/>
          <a:stretch/>
        </p:blipFill>
        <p:spPr bwMode="auto">
          <a:xfrm>
            <a:off x="1389784" y="3332621"/>
            <a:ext cx="6449291" cy="1276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730"/>
          <a:stretch/>
        </p:blipFill>
        <p:spPr bwMode="auto">
          <a:xfrm>
            <a:off x="1362075" y="1336701"/>
            <a:ext cx="6477000" cy="1276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ctangle 5"/>
          <p:cNvSpPr/>
          <p:nvPr/>
        </p:nvSpPr>
        <p:spPr>
          <a:xfrm>
            <a:off x="4953000" y="1371600"/>
            <a:ext cx="381000" cy="3581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4876800" y="1336701"/>
            <a:ext cx="457200" cy="338769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990600" y="10668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047750" y="3086100"/>
            <a:ext cx="628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7171976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71600" y="5029199"/>
            <a:ext cx="6553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15  p.V851A (c.2552T&gt;C,GTC&gt;GCC</a:t>
            </a:r>
            <a:r>
              <a:rPr lang="en-US" dirty="0"/>
              <a:t>)</a:t>
            </a:r>
          </a:p>
          <a:p>
            <a:endParaRPr lang="en-US" dirty="0"/>
          </a:p>
        </p:txBody>
      </p:sp>
      <p:grpSp>
        <p:nvGrpSpPr>
          <p:cNvPr id="5" name="Group 4"/>
          <p:cNvGrpSpPr/>
          <p:nvPr/>
        </p:nvGrpSpPr>
        <p:grpSpPr>
          <a:xfrm>
            <a:off x="1999813" y="1091911"/>
            <a:ext cx="5176405" cy="3416877"/>
            <a:chOff x="1999813" y="1524000"/>
            <a:chExt cx="5176405" cy="3416877"/>
          </a:xfrm>
        </p:grpSpPr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246"/>
            <a:stretch/>
          </p:blipFill>
          <p:spPr bwMode="auto">
            <a:xfrm>
              <a:off x="1999813" y="2937163"/>
              <a:ext cx="5176405" cy="20037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4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321"/>
            <a:stretch/>
          </p:blipFill>
          <p:spPr bwMode="auto">
            <a:xfrm>
              <a:off x="1999813" y="1524000"/>
              <a:ext cx="5176405" cy="1276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" name="Rectangle 1"/>
          <p:cNvSpPr/>
          <p:nvPr/>
        </p:nvSpPr>
        <p:spPr>
          <a:xfrm>
            <a:off x="5105400" y="1219200"/>
            <a:ext cx="381000" cy="32895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1524000" y="1091911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524000" y="27432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9869048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946"/>
          <a:stretch/>
        </p:blipFill>
        <p:spPr bwMode="auto">
          <a:xfrm>
            <a:off x="1676400" y="3415145"/>
            <a:ext cx="6553200" cy="1276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447800" y="5338741"/>
            <a:ext cx="396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ase 30T p.V897A(c.2690T&gt;C, GTC_GCC)</a:t>
            </a:r>
            <a:endParaRPr lang="en-US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7499" r="9562"/>
          <a:stretch/>
        </p:blipFill>
        <p:spPr bwMode="auto">
          <a:xfrm>
            <a:off x="1600200" y="1676400"/>
            <a:ext cx="6553200" cy="1276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5410200" y="1600200"/>
            <a:ext cx="381000" cy="32004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914400" y="14478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066800" y="3415145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0859942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4</TotalTime>
  <Words>141</Words>
  <Application>Microsoft Office PowerPoint</Application>
  <PresentationFormat>On-screen Show (4:3)</PresentationFormat>
  <Paragraphs>40</Paragraphs>
  <Slides>1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5" baseType="lpstr">
      <vt:lpstr>Office Theme</vt:lpstr>
      <vt:lpstr>Electropherograms of the 13 missense mutations in EGFR exons 19–23 detected in hepatocellular carcinoma tissues. (linked to Table3 in the main text)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</dc:creator>
  <cp:lastModifiedBy>002492</cp:lastModifiedBy>
  <cp:revision>110</cp:revision>
  <dcterms:created xsi:type="dcterms:W3CDTF">2013-12-04T11:34:37Z</dcterms:created>
  <dcterms:modified xsi:type="dcterms:W3CDTF">2015-09-15T06:14:19Z</dcterms:modified>
</cp:coreProperties>
</file>